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1.jpeg" ContentType="image/jpeg"/>
  <Override PartName="/ppt/media/image8.png" ContentType="image/png"/>
  <Override PartName="/ppt/media/image14.jpeg" ContentType="image/jpeg"/>
  <Override PartName="/ppt/media/image16.jpeg" ContentType="image/jpeg"/>
  <Override PartName="/ppt/media/image15.jpeg" ContentType="image/jpeg"/>
  <Override PartName="/ppt/media/image1.png" ContentType="image/png"/>
  <Override PartName="/ppt/media/image2.png" ContentType="image/png"/>
  <Override PartName="/ppt/media/image17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2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6C4167-8BCA-49CB-A075-8D614A1C108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"/>
          <p:cNvSpPr/>
          <p:nvPr/>
        </p:nvSpPr>
        <p:spPr>
          <a:xfrm>
            <a:off x="-11798280" y="-11796840"/>
            <a:ext cx="11771280" cy="12465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56160" cy="4084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44000-1DCB-4519-966A-F246BB70D3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ED523-B8AF-4597-BEF8-97F8310512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1D7A5-FA14-4A4E-9561-33D5F52E38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132DD-0EA6-4D9F-95DA-7DCC82240A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0BAD7-D6B8-4319-87C8-3B686F8D75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4A111-1887-409E-B0ED-8C977D9DC8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FD27F-C061-4631-AC5F-1920A9DC38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F5748-A6BC-4126-B522-31E61A8E34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BC86D-7DD2-4686-AF6B-73B0B74333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915FD-8247-4098-979C-DCE54FF3F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99C0A-E7AF-499E-BFC9-1242F4C95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B8BB1-889C-4161-B28A-9E57BA8999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1507D8-B13B-4983-B3E7-B3267F9F449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495360" y="2149560"/>
            <a:ext cx="133344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ananassa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874960" y="2149560"/>
            <a:ext cx="124308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erect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856040" y="2149560"/>
            <a:ext cx="124308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yakub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986520" y="2149560"/>
            <a:ext cx="124308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sechelli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514600" y="4359240"/>
            <a:ext cx="16002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pseudoobscur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890960" y="4359240"/>
            <a:ext cx="89532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virili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913440" y="4359240"/>
            <a:ext cx="12510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mojavensi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08040" y="4359240"/>
            <a:ext cx="11732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willistoni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695680" y="6553080"/>
            <a:ext cx="117288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persimilis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710240" y="6553080"/>
            <a:ext cx="117288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D. simulans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477120" y="6121440"/>
            <a:ext cx="2381040" cy="59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Contain gaps (N's) within the region containing </a:t>
            </a: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Ccp84Aa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and</a:t>
            </a: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 Ccp84Ab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ortholog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228600" y="369720"/>
            <a:ext cx="1828800" cy="18288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2362320" y="369720"/>
            <a:ext cx="1836720" cy="182736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4487760" y="369720"/>
            <a:ext cx="1836720" cy="183204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4"/>
          <a:stretch/>
        </p:blipFill>
        <p:spPr>
          <a:xfrm>
            <a:off x="6629400" y="369720"/>
            <a:ext cx="1828800" cy="182880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5"/>
          <a:stretch/>
        </p:blipFill>
        <p:spPr>
          <a:xfrm>
            <a:off x="228600" y="2579760"/>
            <a:ext cx="1836720" cy="182556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6"/>
          <a:stretch/>
        </p:blipFill>
        <p:spPr>
          <a:xfrm>
            <a:off x="2362320" y="2579760"/>
            <a:ext cx="1828800" cy="182880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7"/>
          <a:stretch/>
        </p:blipFill>
        <p:spPr>
          <a:xfrm>
            <a:off x="4495680" y="2579760"/>
            <a:ext cx="1828800" cy="18288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8"/>
          <a:stretch/>
        </p:blipFill>
        <p:spPr>
          <a:xfrm>
            <a:off x="6629400" y="2579760"/>
            <a:ext cx="1819440" cy="18241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9"/>
          <a:stretch/>
        </p:blipFill>
        <p:spPr>
          <a:xfrm>
            <a:off x="2362320" y="4749840"/>
            <a:ext cx="1828800" cy="182880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10"/>
          <a:stretch/>
        </p:blipFill>
        <p:spPr>
          <a:xfrm>
            <a:off x="4495680" y="4749840"/>
            <a:ext cx="1828800" cy="182880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1219320" y="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ot plots of genes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Ccp84Aa-g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from other Drosophila genom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76320" y="1508040"/>
            <a:ext cx="4572000" cy="4206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1" name=""/>
          <p:cNvSpPr/>
          <p:nvPr/>
        </p:nvSpPr>
        <p:spPr>
          <a:xfrm>
            <a:off x="1779480" y="1127160"/>
            <a:ext cx="199728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3RA grou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4724280" y="1508040"/>
            <a:ext cx="4343400" cy="4175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3" name=""/>
          <p:cNvSpPr/>
          <p:nvPr/>
        </p:nvSpPr>
        <p:spPr>
          <a:xfrm>
            <a:off x="5851440" y="1143000"/>
            <a:ext cx="199728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2RB grou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80880" y="0"/>
            <a:ext cx="8458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t plots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Anopheles gambiae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enomic regions containing highly similar cuticular proteins. See Cornman and Willis (2008) for the specific genes in each group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951280" y="5102280"/>
            <a:ext cx="152280" cy="152280"/>
          </a:xfrm>
          <a:prstGeom prst="ellipse">
            <a:avLst/>
          </a:prstGeom>
          <a:solidFill>
            <a:srgbClr val="ff0000">
              <a:alpha val="23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438880" y="5038560"/>
            <a:ext cx="152280" cy="152640"/>
          </a:xfrm>
          <a:prstGeom prst="ellipse">
            <a:avLst/>
          </a:prstGeom>
          <a:solidFill>
            <a:srgbClr val="ff0000">
              <a:alpha val="23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228600" y="838080"/>
            <a:ext cx="4452840" cy="4010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8" name=""/>
          <p:cNvSpPr/>
          <p:nvPr/>
        </p:nvSpPr>
        <p:spPr>
          <a:xfrm>
            <a:off x="1795320" y="473040"/>
            <a:ext cx="199728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2LB grou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" descr=""/>
          <p:cNvPicPr/>
          <p:nvPr/>
        </p:nvPicPr>
        <p:blipFill>
          <a:blip r:embed="rId2"/>
          <a:stretch/>
        </p:blipFill>
        <p:spPr>
          <a:xfrm>
            <a:off x="4800600" y="838080"/>
            <a:ext cx="4154400" cy="4054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0" name=""/>
          <p:cNvSpPr/>
          <p:nvPr/>
        </p:nvSpPr>
        <p:spPr>
          <a:xfrm>
            <a:off x="5757840" y="473040"/>
            <a:ext cx="199692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2LA grou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80880" y="0"/>
            <a:ext cx="845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t plots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Anopheles gambiae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enomic regions containing highly similar cuticular protei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398600" y="3911760"/>
            <a:ext cx="152280" cy="152280"/>
          </a:xfrm>
          <a:prstGeom prst="ellipse">
            <a:avLst/>
          </a:prstGeom>
          <a:solidFill>
            <a:srgbClr val="ff0000">
              <a:alpha val="23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7620120" y="4249800"/>
            <a:ext cx="152280" cy="152280"/>
          </a:xfrm>
          <a:prstGeom prst="ellipse">
            <a:avLst/>
          </a:prstGeom>
          <a:solidFill>
            <a:srgbClr val="ff0000">
              <a:alpha val="23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228600" y="1603440"/>
            <a:ext cx="5334120" cy="4797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" descr=""/>
          <p:cNvPicPr/>
          <p:nvPr/>
        </p:nvPicPr>
        <p:blipFill>
          <a:blip r:embed="rId2"/>
          <a:stretch/>
        </p:blipFill>
        <p:spPr>
          <a:xfrm>
            <a:off x="5715000" y="1981080"/>
            <a:ext cx="3316320" cy="477540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3505320" y="4343400"/>
            <a:ext cx="3276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09480" y="1222200"/>
            <a:ext cx="548640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2LC group: repeat is weaker than in other </a:t>
            </a:r>
            <a:r>
              <a:rPr b="0" i="1" lang="en-US" sz="1300" spc="-1" strike="noStrike">
                <a:solidFill>
                  <a:srgbClr val="000000"/>
                </a:solidFill>
                <a:latin typeface="Arial"/>
              </a:rPr>
              <a:t>An. gambiae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group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391520" y="4800600"/>
            <a:ext cx="228600" cy="228600"/>
          </a:xfrm>
          <a:prstGeom prst="ellipse">
            <a:avLst/>
          </a:prstGeom>
          <a:solidFill>
            <a:srgbClr val="ff0000">
              <a:alpha val="18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80880" y="0"/>
            <a:ext cx="845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t plots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Anopheles gambiae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enomic regions containing highly similar cuticular protei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" descr=""/>
          <p:cNvPicPr/>
          <p:nvPr/>
        </p:nvPicPr>
        <p:blipFill>
          <a:blip r:embed="rId1"/>
          <a:stretch/>
        </p:blipFill>
        <p:spPr>
          <a:xfrm>
            <a:off x="914400" y="1146240"/>
            <a:ext cx="7162920" cy="5635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1" name=""/>
          <p:cNvSpPr/>
          <p:nvPr/>
        </p:nvSpPr>
        <p:spPr>
          <a:xfrm>
            <a:off x="1889280" y="765000"/>
            <a:ext cx="199692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320" bIns="46800" anchor="t">
            <a:spAutoFit/>
          </a:bodyPr>
          <a:p>
            <a:pPr>
              <a:lnSpc>
                <a:spcPct val="93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PR – 3RB grou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927080" y="5459400"/>
            <a:ext cx="228600" cy="228600"/>
          </a:xfrm>
          <a:prstGeom prst="ellipse">
            <a:avLst/>
          </a:prstGeom>
          <a:solidFill>
            <a:srgbClr val="ff0000">
              <a:alpha val="18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80880" y="0"/>
            <a:ext cx="845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ot plots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Anopheles gambiae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enomic regions containing highly similar cuticular protei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114800" y="5638680"/>
            <a:ext cx="2895480" cy="609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876920" y="5334120"/>
            <a:ext cx="152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ndem repe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5T20:32:28Z</dcterms:created>
  <dc:creator>Anita M. Collins</dc:creator>
  <dc:description/>
  <dc:language>en-US</dc:language>
  <cp:lastModifiedBy>Anita M. Collins</cp:lastModifiedBy>
  <dcterms:modified xsi:type="dcterms:W3CDTF">2009-07-21T20:15:52Z</dcterms:modified>
  <cp:revision>4</cp:revision>
  <dc:subject/>
  <dc:title>Slide 1</dc:title>
</cp:coreProperties>
</file>